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4" d="100"/>
          <a:sy n="84" d="100"/>
        </p:scale>
        <p:origin x="-1450" y="-67"/>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AU"/>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62D8CF8F-4B6D-456D-91BA-C3247AB22690}" type="datetimeFigureOut">
              <a:rPr lang="en-AU" smtClean="0"/>
              <a:t>18/07/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17121167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62D8CF8F-4B6D-456D-91BA-C3247AB22690}" type="datetimeFigureOut">
              <a:rPr lang="en-AU" smtClean="0"/>
              <a:t>18/07/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4242003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62D8CF8F-4B6D-456D-91BA-C3247AB22690}" type="datetimeFigureOut">
              <a:rPr lang="en-AU" smtClean="0"/>
              <a:t>18/07/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19756639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62D8CF8F-4B6D-456D-91BA-C3247AB22690}" type="datetimeFigureOut">
              <a:rPr lang="en-AU" smtClean="0"/>
              <a:t>18/07/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2269718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2D8CF8F-4B6D-456D-91BA-C3247AB22690}" type="datetimeFigureOut">
              <a:rPr lang="en-AU" smtClean="0"/>
              <a:t>18/07/2019</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27311760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62D8CF8F-4B6D-456D-91BA-C3247AB22690}" type="datetimeFigureOut">
              <a:rPr lang="en-AU" smtClean="0"/>
              <a:t>18/07/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13810025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62D8CF8F-4B6D-456D-91BA-C3247AB22690}" type="datetimeFigureOut">
              <a:rPr lang="en-AU" smtClean="0"/>
              <a:t>18/07/2019</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1607725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62D8CF8F-4B6D-456D-91BA-C3247AB22690}" type="datetimeFigureOut">
              <a:rPr lang="en-AU" smtClean="0"/>
              <a:t>18/07/2019</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26481536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D8CF8F-4B6D-456D-91BA-C3247AB22690}" type="datetimeFigureOut">
              <a:rPr lang="en-AU" smtClean="0"/>
              <a:t>18/07/2019</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37603335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2D8CF8F-4B6D-456D-91BA-C3247AB22690}" type="datetimeFigureOut">
              <a:rPr lang="en-AU" smtClean="0"/>
              <a:t>18/07/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19990239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2D8CF8F-4B6D-456D-91BA-C3247AB22690}" type="datetimeFigureOut">
              <a:rPr lang="en-AU" smtClean="0"/>
              <a:t>18/07/2019</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22513C5-009E-46E7-9C9A-CF792FF83CD5}" type="slidenum">
              <a:rPr lang="en-AU" smtClean="0"/>
              <a:t>‹#›</a:t>
            </a:fld>
            <a:endParaRPr lang="en-AU"/>
          </a:p>
        </p:txBody>
      </p:sp>
    </p:spTree>
    <p:extLst>
      <p:ext uri="{BB962C8B-B14F-4D97-AF65-F5344CB8AC3E}">
        <p14:creationId xmlns:p14="http://schemas.microsoft.com/office/powerpoint/2010/main" val="35693827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2D8CF8F-4B6D-456D-91BA-C3247AB22690}" type="datetimeFigureOut">
              <a:rPr lang="en-AU" smtClean="0"/>
              <a:t>18/07/2019</a:t>
            </a:fld>
            <a:endParaRPr lang="en-AU"/>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2513C5-009E-46E7-9C9A-CF792FF83CD5}" type="slidenum">
              <a:rPr lang="en-AU" smtClean="0"/>
              <a:t>‹#›</a:t>
            </a:fld>
            <a:endParaRPr lang="en-AU"/>
          </a:p>
        </p:txBody>
      </p:sp>
    </p:spTree>
    <p:extLst>
      <p:ext uri="{BB962C8B-B14F-4D97-AF65-F5344CB8AC3E}">
        <p14:creationId xmlns:p14="http://schemas.microsoft.com/office/powerpoint/2010/main" val="10536287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620688"/>
            <a:ext cx="7772400" cy="722511"/>
          </a:xfrm>
        </p:spPr>
        <p:txBody>
          <a:bodyPr>
            <a:noAutofit/>
          </a:bodyPr>
          <a:lstStyle/>
          <a:p>
            <a:pPr algn="just"/>
            <a:r>
              <a:rPr lang="en-AU" sz="2000" smtClean="0"/>
              <a:t>Fig. </a:t>
            </a:r>
            <a:r>
              <a:rPr lang="en-AU" sz="2000" dirty="0" smtClean="0"/>
              <a:t>S1</a:t>
            </a:r>
            <a:r>
              <a:rPr lang="en-AU" sz="2000" dirty="0" smtClean="0"/>
              <a:t>. Canola genotypes showing G × E interactions when grown under LD and SD conditions in controlled environment cabinet. Mean flowering time is estimated in days. Details of varieties shown here represented to BC accessions (Supplemental Table S1).</a:t>
            </a:r>
            <a:endParaRPr lang="en-AU" sz="2000" dirty="0"/>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71800" y="1631042"/>
            <a:ext cx="4859630" cy="4853578"/>
          </a:xfrm>
          <a:prstGeom prst="rect">
            <a:avLst/>
          </a:prstGeom>
        </p:spPr>
      </p:pic>
    </p:spTree>
    <p:extLst>
      <p:ext uri="{BB962C8B-B14F-4D97-AF65-F5344CB8AC3E}">
        <p14:creationId xmlns:p14="http://schemas.microsoft.com/office/powerpoint/2010/main" val="9333304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TotalTime>
  <Words>45</Words>
  <Application>Microsoft Office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ig. S1. Canola genotypes showing G × E interactions when grown under LD and SD conditions in controlled environment cabinet. Mean flowering time is estimated in days. Details of varieties shown here represented to BC accessions (Supplemental Table S1).</vt:lpstr>
    </vt:vector>
  </TitlesOfParts>
  <Company>NSW Governmen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SW Government User</dc:creator>
  <cp:lastModifiedBy>NSW Government User</cp:lastModifiedBy>
  <cp:revision>4</cp:revision>
  <dcterms:created xsi:type="dcterms:W3CDTF">2018-08-28T07:31:02Z</dcterms:created>
  <dcterms:modified xsi:type="dcterms:W3CDTF">2019-07-18T00:31:10Z</dcterms:modified>
</cp:coreProperties>
</file>